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7" r:id="rId2"/>
  </p:sldIdLst>
  <p:sldSz cx="12192000" cy="9144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02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4232" autoAdjust="0"/>
    <p:restoredTop sz="94660"/>
  </p:normalViewPr>
  <p:slideViewPr>
    <p:cSldViewPr snapToGrid="0">
      <p:cViewPr varScale="1">
        <p:scale>
          <a:sx n="77" d="100"/>
          <a:sy n="77" d="100"/>
        </p:scale>
        <p:origin x="-690" y="-102"/>
      </p:cViewPr>
      <p:guideLst>
        <p:guide orient="horz" pos="102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8CB7CB-FEBB-4334-8522-FA0D37ABD8ED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57DF26-5A18-4996-9CD9-7A05E92A9A2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66910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914400" y="2840569"/>
            <a:ext cx="103632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828800" y="5181600"/>
            <a:ext cx="85344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8128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6256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4384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2512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0640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8768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6896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65024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8258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01709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839200" y="366188"/>
            <a:ext cx="2743200" cy="780203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609600" y="366188"/>
            <a:ext cx="8026400" cy="780203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60741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263495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63084" y="5875867"/>
            <a:ext cx="10363200" cy="1816100"/>
          </a:xfrm>
        </p:spPr>
        <p:txBody>
          <a:bodyPr anchor="t"/>
          <a:lstStyle>
            <a:lvl1pPr algn="l">
              <a:defRPr sz="7111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63084" y="3875621"/>
            <a:ext cx="10363200" cy="2000249"/>
          </a:xfrm>
        </p:spPr>
        <p:txBody>
          <a:bodyPr anchor="b"/>
          <a:lstStyle>
            <a:lvl1pPr marL="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1pPr>
            <a:lvl2pPr marL="81281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13493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609600" y="2133604"/>
            <a:ext cx="5384800" cy="6034617"/>
          </a:xfrm>
        </p:spPr>
        <p:txBody>
          <a:bodyPr/>
          <a:lstStyle>
            <a:lvl1pPr>
              <a:defRPr sz="4978"/>
            </a:lvl1pPr>
            <a:lvl2pPr>
              <a:defRPr sz="4267"/>
            </a:lvl2pPr>
            <a:lvl3pPr>
              <a:defRPr sz="3556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97600" y="2133604"/>
            <a:ext cx="5384800" cy="6034617"/>
          </a:xfrm>
        </p:spPr>
        <p:txBody>
          <a:bodyPr/>
          <a:lstStyle>
            <a:lvl1pPr>
              <a:defRPr sz="4978"/>
            </a:lvl1pPr>
            <a:lvl2pPr>
              <a:defRPr sz="4267"/>
            </a:lvl2pPr>
            <a:lvl3pPr>
              <a:defRPr sz="3556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85780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3" y="2046817"/>
            <a:ext cx="5386917" cy="853016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09603" y="2899833"/>
            <a:ext cx="5386917" cy="5268384"/>
          </a:xfrm>
        </p:spPr>
        <p:txBody>
          <a:bodyPr/>
          <a:lstStyle>
            <a:lvl1pPr>
              <a:defRPr sz="4267"/>
            </a:lvl1pPr>
            <a:lvl2pPr>
              <a:defRPr sz="3556"/>
            </a:lvl2pPr>
            <a:lvl3pPr>
              <a:defRPr sz="3200"/>
            </a:lvl3pPr>
            <a:lvl4pPr>
              <a:defRPr sz="2844"/>
            </a:lvl4pPr>
            <a:lvl5pPr>
              <a:defRPr sz="2844"/>
            </a:lvl5pPr>
            <a:lvl6pPr>
              <a:defRPr sz="2844"/>
            </a:lvl6pPr>
            <a:lvl7pPr>
              <a:defRPr sz="2844"/>
            </a:lvl7pPr>
            <a:lvl8pPr>
              <a:defRPr sz="2844"/>
            </a:lvl8pPr>
            <a:lvl9pPr>
              <a:defRPr sz="2844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93370" y="2046817"/>
            <a:ext cx="5389033" cy="853016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93370" y="2899833"/>
            <a:ext cx="5389033" cy="5268384"/>
          </a:xfrm>
        </p:spPr>
        <p:txBody>
          <a:bodyPr/>
          <a:lstStyle>
            <a:lvl1pPr>
              <a:defRPr sz="4267"/>
            </a:lvl1pPr>
            <a:lvl2pPr>
              <a:defRPr sz="3556"/>
            </a:lvl2pPr>
            <a:lvl3pPr>
              <a:defRPr sz="3200"/>
            </a:lvl3pPr>
            <a:lvl4pPr>
              <a:defRPr sz="2844"/>
            </a:lvl4pPr>
            <a:lvl5pPr>
              <a:defRPr sz="2844"/>
            </a:lvl5pPr>
            <a:lvl6pPr>
              <a:defRPr sz="2844"/>
            </a:lvl6pPr>
            <a:lvl7pPr>
              <a:defRPr sz="2844"/>
            </a:lvl7pPr>
            <a:lvl8pPr>
              <a:defRPr sz="2844"/>
            </a:lvl8pPr>
            <a:lvl9pPr>
              <a:defRPr sz="2844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659522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07597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5596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1" y="364067"/>
            <a:ext cx="4011084" cy="1549400"/>
          </a:xfrm>
        </p:spPr>
        <p:txBody>
          <a:bodyPr anchor="b"/>
          <a:lstStyle>
            <a:lvl1pPr algn="l">
              <a:defRPr sz="3556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766733" y="364070"/>
            <a:ext cx="6815668" cy="7804151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09601" y="1913470"/>
            <a:ext cx="4011084" cy="6254751"/>
          </a:xfrm>
        </p:spPr>
        <p:txBody>
          <a:bodyPr/>
          <a:lstStyle>
            <a:lvl1pPr marL="0" indent="0">
              <a:buNone/>
              <a:defRPr sz="2489"/>
            </a:lvl1pPr>
            <a:lvl2pPr marL="812810" indent="0">
              <a:buNone/>
              <a:defRPr sz="2133"/>
            </a:lvl2pPr>
            <a:lvl3pPr marL="1625620" indent="0">
              <a:buNone/>
              <a:defRPr sz="1778"/>
            </a:lvl3pPr>
            <a:lvl4pPr marL="2438430" indent="0">
              <a:buNone/>
              <a:defRPr sz="1600"/>
            </a:lvl4pPr>
            <a:lvl5pPr marL="3251241" indent="0">
              <a:buNone/>
              <a:defRPr sz="1600"/>
            </a:lvl5pPr>
            <a:lvl6pPr marL="4064051" indent="0">
              <a:buNone/>
              <a:defRPr sz="1600"/>
            </a:lvl6pPr>
            <a:lvl7pPr marL="4876861" indent="0">
              <a:buNone/>
              <a:defRPr sz="1600"/>
            </a:lvl7pPr>
            <a:lvl8pPr marL="5689671" indent="0">
              <a:buNone/>
              <a:defRPr sz="1600"/>
            </a:lvl8pPr>
            <a:lvl9pPr marL="6502481" indent="0">
              <a:buNone/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65922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9717" y="6400803"/>
            <a:ext cx="7315200" cy="755651"/>
          </a:xfrm>
        </p:spPr>
        <p:txBody>
          <a:bodyPr anchor="b"/>
          <a:lstStyle>
            <a:lvl1pPr algn="l">
              <a:defRPr sz="3556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89717" y="817033"/>
            <a:ext cx="7315200" cy="5486400"/>
          </a:xfrm>
        </p:spPr>
        <p:txBody>
          <a:bodyPr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89717" y="7156454"/>
            <a:ext cx="7315200" cy="1073149"/>
          </a:xfrm>
        </p:spPr>
        <p:txBody>
          <a:bodyPr/>
          <a:lstStyle>
            <a:lvl1pPr marL="0" indent="0">
              <a:buNone/>
              <a:defRPr sz="2489"/>
            </a:lvl1pPr>
            <a:lvl2pPr marL="812810" indent="0">
              <a:buNone/>
              <a:defRPr sz="2133"/>
            </a:lvl2pPr>
            <a:lvl3pPr marL="1625620" indent="0">
              <a:buNone/>
              <a:defRPr sz="1778"/>
            </a:lvl3pPr>
            <a:lvl4pPr marL="2438430" indent="0">
              <a:buNone/>
              <a:defRPr sz="1600"/>
            </a:lvl4pPr>
            <a:lvl5pPr marL="3251241" indent="0">
              <a:buNone/>
              <a:defRPr sz="1600"/>
            </a:lvl5pPr>
            <a:lvl6pPr marL="4064051" indent="0">
              <a:buNone/>
              <a:defRPr sz="1600"/>
            </a:lvl6pPr>
            <a:lvl7pPr marL="4876861" indent="0">
              <a:buNone/>
              <a:defRPr sz="1600"/>
            </a:lvl7pPr>
            <a:lvl8pPr marL="5689671" indent="0">
              <a:buNone/>
              <a:defRPr sz="1600"/>
            </a:lvl8pPr>
            <a:lvl9pPr marL="6502481" indent="0">
              <a:buNone/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94534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609600" y="366184"/>
            <a:ext cx="109728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0" y="2133604"/>
            <a:ext cx="109728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609600" y="8475137"/>
            <a:ext cx="284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165600" y="8475137"/>
            <a:ext cx="3860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737600" y="8475137"/>
            <a:ext cx="284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81071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625620" rtl="0" eaLnBrk="1" latinLnBrk="1" hangingPunct="1"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09608" indent="-609608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5689" kern="1200">
          <a:solidFill>
            <a:schemeClr val="tx1"/>
          </a:solidFill>
          <a:latin typeface="+mn-lt"/>
          <a:ea typeface="+mn-ea"/>
          <a:cs typeface="+mn-cs"/>
        </a:defRPr>
      </a:lvl1pPr>
      <a:lvl2pPr marL="1320817" indent="-508006" algn="l" defTabSz="1625620" rtl="0" eaLnBrk="1" latinLnBrk="1" hangingPunct="1">
        <a:spcBef>
          <a:spcPct val="20000"/>
        </a:spcBef>
        <a:buFont typeface="Arial" panose="020B0604020202020204" pitchFamily="34" charset="0"/>
        <a:buChar char="–"/>
        <a:defRPr sz="4978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–"/>
        <a:defRPr sz="3556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»"/>
        <a:defRPr sz="3556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표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58186276"/>
              </p:ext>
            </p:extLst>
          </p:nvPr>
        </p:nvGraphicFramePr>
        <p:xfrm>
          <a:off x="149625" y="1017132"/>
          <a:ext cx="11538795" cy="6042845"/>
        </p:xfrm>
        <a:graphic>
          <a:graphicData uri="http://schemas.openxmlformats.org/drawingml/2006/table">
            <a:tbl>
              <a:tblPr firstRow="1" firstCol="1" bandRow="1"/>
              <a:tblGrid>
                <a:gridCol w="1467140"/>
                <a:gridCol w="2438400"/>
                <a:gridCol w="1593608"/>
                <a:gridCol w="1593608"/>
                <a:gridCol w="1593608"/>
                <a:gridCol w="1593608"/>
                <a:gridCol w="1258823"/>
              </a:tblGrid>
              <a:tr h="891181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b="0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ene_Name</a:t>
                      </a:r>
                      <a:endParaRPr lang="ko-KR" sz="1600" b="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b="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ocus</a:t>
                      </a:r>
                      <a:endParaRPr lang="ko-KR" sz="1600" b="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b="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verage (Normal colon)</a:t>
                      </a:r>
                      <a:endParaRPr lang="ko-KR" sz="1600" b="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b="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verage (primary colon cancer)</a:t>
                      </a:r>
                      <a:endParaRPr lang="ko-KR" sz="1600" b="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b="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verage (Normal liver)</a:t>
                      </a:r>
                      <a:endParaRPr lang="ko-KR" sz="1600" b="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b="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verage (Liver </a:t>
                      </a:r>
                      <a:r>
                        <a:rPr lang="en-US" sz="1600" b="0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etastase</a:t>
                      </a:r>
                      <a:r>
                        <a:rPr lang="en-US" sz="1600" b="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)</a:t>
                      </a:r>
                      <a:endParaRPr lang="ko-KR" sz="1600" b="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b="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old change</a:t>
                      </a:r>
                      <a:endParaRPr lang="ko-KR" sz="1600" b="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7976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NKRD55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:55395506-55529186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.728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822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1.656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2.002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.797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67976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1orf228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:45140393-45191263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712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850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5.194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.039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.591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67976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HST9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8:24432006-24765302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5.572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00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2.861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8.310</a:t>
                      </a:r>
                      <a:endParaRPr lang="ko-KR" sz="16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en-US" altLang="ko-KR" sz="1600" kern="100" dirty="0" smtClean="0"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*</a:t>
                      </a:r>
                      <a:endParaRPr lang="ko-KR" sz="16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67976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IFITM10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:1753639-1772010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5.073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2.068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55.765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9.672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944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67976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INC00310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1:35552977-35562220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5.624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.648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6.374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6.460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779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67976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ST1L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:16767166-17091195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7.811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.942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36.914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1.528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.042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67976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YO7A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:76839309-76926287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9.837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7.427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11.793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1.100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780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67976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NALCN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:101360578-102069506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948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207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626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.185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615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67976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RSS53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6:31085742-31100130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.060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.093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5.646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7.468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873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67976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USD2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2:24577443-24585074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8.000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6.238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7.258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7.622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274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67976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IMD4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:156346292-156390266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2.208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932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68.082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3.508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.136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67976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VTI1A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:114206755-114578503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.100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.755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8.903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1.045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530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67976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AHM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:163834096-163834982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5.628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389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4.550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.480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387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67976"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LEC10A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7:6977855-6983958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1.932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.714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8.498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2.559</a:t>
                      </a:r>
                      <a:endParaRPr lang="ko-KR" sz="16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352</a:t>
                      </a:r>
                      <a:endParaRPr lang="ko-KR" sz="16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9" name="직사각형 8"/>
          <p:cNvSpPr/>
          <p:nvPr/>
        </p:nvSpPr>
        <p:spPr>
          <a:xfrm>
            <a:off x="-3324" y="583270"/>
            <a:ext cx="12189883" cy="420610"/>
          </a:xfrm>
          <a:prstGeom prst="rect">
            <a:avLst/>
          </a:prstGeom>
        </p:spPr>
        <p:txBody>
          <a:bodyPr wrap="square" lIns="142224" tIns="71111" rIns="142224" bIns="71111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3. Genes (n=14) associated with liver metastases as compared to primary tumors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n-US" altLang="ko-K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159168" y="7199002"/>
            <a:ext cx="68194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PKM expression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not detected in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imary colon cancer therefore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ld change could not be calculated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753082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70</TotalTime>
  <Words>157</Words>
  <Application>Microsoft Office PowerPoint</Application>
  <PresentationFormat>Custom</PresentationFormat>
  <Paragraphs>10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 Author</dc:creator>
  <cp:lastModifiedBy>Real, Francis Frank</cp:lastModifiedBy>
  <cp:revision>55</cp:revision>
  <dcterms:created xsi:type="dcterms:W3CDTF">2015-06-22T23:51:12Z</dcterms:created>
  <dcterms:modified xsi:type="dcterms:W3CDTF">2016-07-26T03:44:52Z</dcterms:modified>
</cp:coreProperties>
</file>